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  <p:sldId id="266" r:id="rId4"/>
    <p:sldId id="267" r:id="rId5"/>
    <p:sldId id="260" r:id="rId6"/>
    <p:sldId id="263" r:id="rId7"/>
    <p:sldId id="265" r:id="rId8"/>
    <p:sldId id="262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4" d="100"/>
          <a:sy n="84" d="100"/>
        </p:scale>
        <p:origin x="629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6413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6DCF2-9FB6-4F09-90EE-470DAD842DDC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965E-75A8-4060-AF65-A9D8B0C852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6638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6DCF2-9FB6-4F09-90EE-470DAD842DDC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965E-75A8-4060-AF65-A9D8B0C852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4659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6DCF2-9FB6-4F09-90EE-470DAD842DDC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965E-75A8-4060-AF65-A9D8B0C852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3329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6DCF2-9FB6-4F09-90EE-470DAD842DDC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965E-75A8-4060-AF65-A9D8B0C852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7928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6DCF2-9FB6-4F09-90EE-470DAD842DDC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965E-75A8-4060-AF65-A9D8B0C852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8442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6DCF2-9FB6-4F09-90EE-470DAD842DDC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965E-75A8-4060-AF65-A9D8B0C852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575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6DCF2-9FB6-4F09-90EE-470DAD842DDC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965E-75A8-4060-AF65-A9D8B0C852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8264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6DCF2-9FB6-4F09-90EE-470DAD842DDC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965E-75A8-4060-AF65-A9D8B0C852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509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6DCF2-9FB6-4F09-90EE-470DAD842DDC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965E-75A8-4060-AF65-A9D8B0C852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81808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6DCF2-9FB6-4F09-90EE-470DAD842DDC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965E-75A8-4060-AF65-A9D8B0C852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5895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6DCF2-9FB6-4F09-90EE-470DAD842DDC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965E-75A8-4060-AF65-A9D8B0C852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8327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76DCF2-9FB6-4F09-90EE-470DAD842DDC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E965E-75A8-4060-AF65-A9D8B0C852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1963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6720" y="-2180750"/>
            <a:ext cx="5998003" cy="8247254"/>
          </a:xfrm>
          <a:prstGeom prst="rect">
            <a:avLst/>
          </a:prstGeom>
        </p:spPr>
      </p:pic>
      <p:sp>
        <p:nvSpPr>
          <p:cNvPr id="24" name="矩形 23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4663124" y="3901750"/>
            <a:ext cx="10977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6057452" y="3901750"/>
            <a:ext cx="10977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xmlns="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4916506" y="4145003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7" name="矩形 26">
            <a:extLst>
              <a:ext uri="{FF2B5EF4-FFF2-40B4-BE49-F238E27FC236}">
                <a16:creationId xmlns:a16="http://schemas.microsoft.com/office/drawing/2014/main" xmlns="" id="{E1DB421E-9ACF-464C-8ACB-D1AB43B55ABB}"/>
              </a:ext>
            </a:extLst>
          </p:cNvPr>
          <p:cNvSpPr/>
          <p:nvPr/>
        </p:nvSpPr>
        <p:spPr>
          <a:xfrm>
            <a:off x="4823677" y="3844267"/>
            <a:ext cx="15354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5162892" y="4077441"/>
            <a:ext cx="7225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5535682" y="4016283"/>
            <a:ext cx="8531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xmlns="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6312084" y="4145003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1" name="矩形 30">
            <a:extLst>
              <a:ext uri="{FF2B5EF4-FFF2-40B4-BE49-F238E27FC236}">
                <a16:creationId xmlns:a16="http://schemas.microsoft.com/office/drawing/2014/main" xmlns="" id="{E1DB421E-9ACF-464C-8ACB-D1AB43B55ABB}"/>
              </a:ext>
            </a:extLst>
          </p:cNvPr>
          <p:cNvSpPr/>
          <p:nvPr/>
        </p:nvSpPr>
        <p:spPr>
          <a:xfrm>
            <a:off x="6498168" y="3844267"/>
            <a:ext cx="7959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6597037" y="4134855"/>
            <a:ext cx="59997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6978494" y="4086194"/>
            <a:ext cx="70388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4875504" y="3429337"/>
            <a:ext cx="1321921" cy="445628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6197424" y="3429337"/>
            <a:ext cx="1284659" cy="445628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7597913" y="4194137"/>
            <a:ext cx="6206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1.7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组合 36"/>
          <p:cNvGrpSpPr/>
          <p:nvPr/>
        </p:nvGrpSpPr>
        <p:grpSpPr>
          <a:xfrm>
            <a:off x="3592168" y="3524453"/>
            <a:ext cx="585417" cy="276999"/>
            <a:chOff x="-4007534" y="10215563"/>
            <a:chExt cx="585417" cy="276999"/>
          </a:xfrm>
        </p:grpSpPr>
        <p:sp>
          <p:nvSpPr>
            <p:cNvPr id="38" name="矩形 37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直接连接符 38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0" name="组合 39"/>
          <p:cNvGrpSpPr/>
          <p:nvPr/>
        </p:nvGrpSpPr>
        <p:grpSpPr>
          <a:xfrm>
            <a:off x="3592154" y="3923558"/>
            <a:ext cx="585417" cy="276999"/>
            <a:chOff x="-4007534" y="10215563"/>
            <a:chExt cx="585417" cy="276999"/>
          </a:xfrm>
        </p:grpSpPr>
        <p:sp>
          <p:nvSpPr>
            <p:cNvPr id="41" name="矩形 40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接连接符 41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3" name="标题 1">
            <a:extLst>
              <a:ext uri="{FF2B5EF4-FFF2-40B4-BE49-F238E27FC236}">
                <a16:creationId xmlns:a16="http://schemas.microsoft.com/office/drawing/2014/main" xmlns="" id="{5A3072FC-4A10-4645-A8E2-D8FEC07D3815}"/>
              </a:ext>
            </a:extLst>
          </p:cNvPr>
          <p:cNvSpPr txBox="1">
            <a:spLocks/>
          </p:cNvSpPr>
          <p:nvPr/>
        </p:nvSpPr>
        <p:spPr>
          <a:xfrm>
            <a:off x="-200547" y="681431"/>
            <a:ext cx="4342104" cy="577970"/>
          </a:xfrm>
          <a:prstGeom prst="rect">
            <a:avLst/>
          </a:prstGeom>
        </p:spPr>
        <p:txBody>
          <a:bodyPr>
            <a:normAutofit lnSpcReduction="10000"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sz="32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hospho-CDK1-T14</a:t>
            </a:r>
            <a:endParaRPr lang="zh-CN" altLang="en-US" sz="32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13021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C9BB3BD-898E-45C3-9AC4-47CF9D298AB6}"/>
              </a:ext>
            </a:extLst>
          </p:cNvPr>
          <p:cNvSpPr txBox="1">
            <a:spLocks/>
          </p:cNvSpPr>
          <p:nvPr/>
        </p:nvSpPr>
        <p:spPr>
          <a:xfrm>
            <a:off x="0" y="572224"/>
            <a:ext cx="3002280" cy="577970"/>
          </a:xfrm>
          <a:prstGeom prst="rect">
            <a:avLst/>
          </a:prstGeom>
        </p:spPr>
        <p:txBody>
          <a:bodyPr>
            <a:normAutofit lnSpcReduction="10000"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sz="32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CDK1</a:t>
            </a:r>
            <a:endParaRPr lang="zh-CN" altLang="en-US" sz="32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5680" y="-2159650"/>
            <a:ext cx="6558291" cy="9017650"/>
          </a:xfrm>
          <a:prstGeom prst="rect">
            <a:avLst/>
          </a:prstGeom>
        </p:spPr>
      </p:pic>
      <p:sp>
        <p:nvSpPr>
          <p:cNvPr id="26" name="矩形 25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4663124" y="3883970"/>
            <a:ext cx="10977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6057452" y="3883970"/>
            <a:ext cx="10977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xmlns="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4916506" y="4127223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9" name="矩形 28">
            <a:extLst>
              <a:ext uri="{FF2B5EF4-FFF2-40B4-BE49-F238E27FC236}">
                <a16:creationId xmlns:a16="http://schemas.microsoft.com/office/drawing/2014/main" xmlns="" id="{E1DB421E-9ACF-464C-8ACB-D1AB43B55ABB}"/>
              </a:ext>
            </a:extLst>
          </p:cNvPr>
          <p:cNvSpPr/>
          <p:nvPr/>
        </p:nvSpPr>
        <p:spPr>
          <a:xfrm>
            <a:off x="4823677" y="3826487"/>
            <a:ext cx="15354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5162892" y="4059661"/>
            <a:ext cx="7225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5535682" y="3998503"/>
            <a:ext cx="8531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xmlns="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6312084" y="4127223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3" name="矩形 32">
            <a:extLst>
              <a:ext uri="{FF2B5EF4-FFF2-40B4-BE49-F238E27FC236}">
                <a16:creationId xmlns:a16="http://schemas.microsoft.com/office/drawing/2014/main" xmlns="" id="{E1DB421E-9ACF-464C-8ACB-D1AB43B55ABB}"/>
              </a:ext>
            </a:extLst>
          </p:cNvPr>
          <p:cNvSpPr/>
          <p:nvPr/>
        </p:nvSpPr>
        <p:spPr>
          <a:xfrm>
            <a:off x="6498168" y="3826487"/>
            <a:ext cx="7959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6597037" y="4117075"/>
            <a:ext cx="59997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6978494" y="4068414"/>
            <a:ext cx="70388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矩形 56"/>
          <p:cNvSpPr/>
          <p:nvPr/>
        </p:nvSpPr>
        <p:spPr>
          <a:xfrm>
            <a:off x="4875504" y="3429337"/>
            <a:ext cx="1321921" cy="445628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6197424" y="3429337"/>
            <a:ext cx="1284659" cy="445628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矩形 58"/>
          <p:cNvSpPr/>
          <p:nvPr/>
        </p:nvSpPr>
        <p:spPr>
          <a:xfrm>
            <a:off x="7597913" y="4176357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123.8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0" name="组合 59"/>
          <p:cNvGrpSpPr/>
          <p:nvPr/>
        </p:nvGrpSpPr>
        <p:grpSpPr>
          <a:xfrm>
            <a:off x="3592168" y="3524453"/>
            <a:ext cx="585417" cy="276999"/>
            <a:chOff x="-4007534" y="10215563"/>
            <a:chExt cx="585417" cy="276999"/>
          </a:xfrm>
        </p:grpSpPr>
        <p:sp>
          <p:nvSpPr>
            <p:cNvPr id="61" name="矩形 60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" name="直接连接符 61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3" name="组合 62"/>
          <p:cNvGrpSpPr/>
          <p:nvPr/>
        </p:nvGrpSpPr>
        <p:grpSpPr>
          <a:xfrm>
            <a:off x="3592154" y="3923558"/>
            <a:ext cx="585417" cy="276999"/>
            <a:chOff x="-4007534" y="10215563"/>
            <a:chExt cx="585417" cy="276999"/>
          </a:xfrm>
        </p:grpSpPr>
        <p:sp>
          <p:nvSpPr>
            <p:cNvPr id="64" name="矩形 63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5" name="直接连接符 64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456889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ED2871F-E1FF-49FE-B421-8F07D564E8A1}"/>
              </a:ext>
            </a:extLst>
          </p:cNvPr>
          <p:cNvSpPr txBox="1">
            <a:spLocks/>
          </p:cNvSpPr>
          <p:nvPr/>
        </p:nvSpPr>
        <p:spPr>
          <a:xfrm>
            <a:off x="552450" y="319991"/>
            <a:ext cx="1657180" cy="577970"/>
          </a:xfrm>
          <a:prstGeom prst="rect">
            <a:avLst/>
          </a:prstGeom>
        </p:spPr>
        <p:txBody>
          <a:bodyPr>
            <a:normAutofit lnSpcReduction="10000"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γ-</a:t>
            </a:r>
            <a:r>
              <a:rPr lang="en-US" altLang="zh-CN" sz="3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2A</a:t>
            </a:r>
            <a:r>
              <a:rPr lang="en-US" altLang="zh-CN" sz="32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</a:t>
            </a:r>
            <a:endParaRPr lang="zh-CN" altLang="en-US" sz="32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9703" y="-1841672"/>
            <a:ext cx="5626473" cy="7736400"/>
          </a:xfrm>
          <a:prstGeom prst="rect">
            <a:avLst/>
          </a:prstGeom>
        </p:spPr>
      </p:pic>
      <p:sp>
        <p:nvSpPr>
          <p:cNvPr id="57" name="矩形 56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4549193" y="4791301"/>
            <a:ext cx="10977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xmlns="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4802575" y="5034554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5" name="矩形 74">
            <a:extLst>
              <a:ext uri="{FF2B5EF4-FFF2-40B4-BE49-F238E27FC236}">
                <a16:creationId xmlns:a16="http://schemas.microsoft.com/office/drawing/2014/main" xmlns="" id="{E1DB421E-9ACF-464C-8ACB-D1AB43B55ABB}"/>
              </a:ext>
            </a:extLst>
          </p:cNvPr>
          <p:cNvSpPr/>
          <p:nvPr/>
        </p:nvSpPr>
        <p:spPr>
          <a:xfrm>
            <a:off x="4709746" y="4733818"/>
            <a:ext cx="15354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5048961" y="4966992"/>
            <a:ext cx="7225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矩形 78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5421751" y="4905834"/>
            <a:ext cx="8531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矩形 82"/>
          <p:cNvSpPr/>
          <p:nvPr/>
        </p:nvSpPr>
        <p:spPr>
          <a:xfrm>
            <a:off x="4761573" y="4298568"/>
            <a:ext cx="1321921" cy="445628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4" name="组合 83"/>
          <p:cNvGrpSpPr/>
          <p:nvPr/>
        </p:nvGrpSpPr>
        <p:grpSpPr>
          <a:xfrm>
            <a:off x="4045241" y="3978086"/>
            <a:ext cx="585417" cy="276999"/>
            <a:chOff x="-4007534" y="10215563"/>
            <a:chExt cx="585417" cy="276999"/>
          </a:xfrm>
        </p:grpSpPr>
        <p:sp>
          <p:nvSpPr>
            <p:cNvPr id="85" name="矩形 84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6" name="直接连接符 85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7" name="组合 86"/>
          <p:cNvGrpSpPr/>
          <p:nvPr/>
        </p:nvGrpSpPr>
        <p:grpSpPr>
          <a:xfrm>
            <a:off x="4045227" y="4618491"/>
            <a:ext cx="585417" cy="276999"/>
            <a:chOff x="-4007534" y="10215563"/>
            <a:chExt cx="585417" cy="276999"/>
          </a:xfrm>
        </p:grpSpPr>
        <p:sp>
          <p:nvSpPr>
            <p:cNvPr id="88" name="矩形 87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9" name="直接连接符 88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0" name="矩形 89">
            <a:extLst>
              <a:ext uri="{FF2B5EF4-FFF2-40B4-BE49-F238E27FC236}">
                <a16:creationId xmlns:a16="http://schemas.microsoft.com/office/drawing/2014/main" xmlns="" id="{04F2603A-4C99-4014-9048-120CB6C8E32E}"/>
              </a:ext>
            </a:extLst>
          </p:cNvPr>
          <p:cNvSpPr/>
          <p:nvPr/>
        </p:nvSpPr>
        <p:spPr>
          <a:xfrm flipH="1">
            <a:off x="7261679" y="4680066"/>
            <a:ext cx="863268" cy="379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867" dirty="0" err="1" smtClean="0">
                <a:latin typeface="Arial" panose="020B0604020202020204" pitchFamily="34" charset="0"/>
                <a:cs typeface="Arial" panose="020B0604020202020204" pitchFamily="34" charset="0"/>
              </a:rPr>
              <a:t>0.3s</a:t>
            </a:r>
            <a:endParaRPr lang="zh-CN" altLang="en-US" sz="186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96931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1468" y="-2332929"/>
            <a:ext cx="5626473" cy="773640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469468" y="3909695"/>
            <a:ext cx="10977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xmlns="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3722850" y="4152948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" name="矩形 4">
            <a:extLst>
              <a:ext uri="{FF2B5EF4-FFF2-40B4-BE49-F238E27FC236}">
                <a16:creationId xmlns:a16="http://schemas.microsoft.com/office/drawing/2014/main" xmlns="" id="{E1DB421E-9ACF-464C-8ACB-D1AB43B55ABB}"/>
              </a:ext>
            </a:extLst>
          </p:cNvPr>
          <p:cNvSpPr/>
          <p:nvPr/>
        </p:nvSpPr>
        <p:spPr>
          <a:xfrm>
            <a:off x="3914501" y="3852212"/>
            <a:ext cx="7959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969236" y="4085386"/>
            <a:ext cx="7225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4342026" y="4024228"/>
            <a:ext cx="8531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681848" y="3416962"/>
            <a:ext cx="1321921" cy="445628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2965516" y="3096480"/>
            <a:ext cx="585417" cy="276999"/>
            <a:chOff x="-4007534" y="10215563"/>
            <a:chExt cx="585417" cy="276999"/>
          </a:xfrm>
        </p:grpSpPr>
        <p:sp>
          <p:nvSpPr>
            <p:cNvPr id="10" name="矩形 9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直接连接符 10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" name="组合 11"/>
          <p:cNvGrpSpPr/>
          <p:nvPr/>
        </p:nvGrpSpPr>
        <p:grpSpPr>
          <a:xfrm>
            <a:off x="2965502" y="3736885"/>
            <a:ext cx="585417" cy="276999"/>
            <a:chOff x="-4007534" y="10215563"/>
            <a:chExt cx="585417" cy="276999"/>
          </a:xfrm>
        </p:grpSpPr>
        <p:sp>
          <p:nvSpPr>
            <p:cNvPr id="13" name="矩形 12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1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5" name="矩形 14">
            <a:extLst>
              <a:ext uri="{FF2B5EF4-FFF2-40B4-BE49-F238E27FC236}">
                <a16:creationId xmlns:a16="http://schemas.microsoft.com/office/drawing/2014/main" xmlns="" id="{04F2603A-4C99-4014-9048-120CB6C8E32E}"/>
              </a:ext>
            </a:extLst>
          </p:cNvPr>
          <p:cNvSpPr/>
          <p:nvPr/>
        </p:nvSpPr>
        <p:spPr>
          <a:xfrm flipH="1">
            <a:off x="6181954" y="3798460"/>
            <a:ext cx="863268" cy="379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867" dirty="0" err="1" smtClean="0">
                <a:latin typeface="Arial" panose="020B0604020202020204" pitchFamily="34" charset="0"/>
                <a:cs typeface="Arial" panose="020B0604020202020204" pitchFamily="34" charset="0"/>
              </a:rPr>
              <a:t>0.5s</a:t>
            </a:r>
            <a:endParaRPr lang="zh-CN" altLang="en-US" sz="186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标题 1">
            <a:extLst>
              <a:ext uri="{FF2B5EF4-FFF2-40B4-BE49-F238E27FC236}">
                <a16:creationId xmlns:a16="http://schemas.microsoft.com/office/drawing/2014/main" xmlns="" id="{CED2871F-E1FF-49FE-B421-8F07D564E8A1}"/>
              </a:ext>
            </a:extLst>
          </p:cNvPr>
          <p:cNvSpPr txBox="1">
            <a:spLocks/>
          </p:cNvSpPr>
          <p:nvPr/>
        </p:nvSpPr>
        <p:spPr>
          <a:xfrm>
            <a:off x="552450" y="319991"/>
            <a:ext cx="1657180" cy="577970"/>
          </a:xfrm>
          <a:prstGeom prst="rect">
            <a:avLst/>
          </a:prstGeom>
        </p:spPr>
        <p:txBody>
          <a:bodyPr>
            <a:normAutofit lnSpcReduction="10000"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γ-</a:t>
            </a:r>
            <a:r>
              <a:rPr lang="en-US" altLang="zh-CN" sz="3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2A</a:t>
            </a:r>
            <a:r>
              <a:rPr lang="en-US" altLang="zh-CN" sz="32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</a:t>
            </a:r>
            <a:endParaRPr lang="zh-CN" altLang="en-US" sz="32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78153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AC2502D-7B2E-4F08-B5EE-2805D9896CB1}"/>
              </a:ext>
            </a:extLst>
          </p:cNvPr>
          <p:cNvSpPr txBox="1">
            <a:spLocks/>
          </p:cNvSpPr>
          <p:nvPr/>
        </p:nvSpPr>
        <p:spPr>
          <a:xfrm>
            <a:off x="552450" y="319991"/>
            <a:ext cx="971550" cy="577970"/>
          </a:xfrm>
          <a:prstGeom prst="rect">
            <a:avLst/>
          </a:prstGeom>
        </p:spPr>
        <p:txBody>
          <a:bodyPr>
            <a:normAutofit lnSpcReduction="10000"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sz="32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H3</a:t>
            </a:r>
            <a:endParaRPr lang="zh-CN" altLang="en-US" sz="32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3950" y="-1547262"/>
            <a:ext cx="5626114" cy="7735907"/>
          </a:xfrm>
          <a:prstGeom prst="rect">
            <a:avLst/>
          </a:prstGeom>
        </p:spPr>
      </p:pic>
      <p:sp>
        <p:nvSpPr>
          <p:cNvPr id="71" name="矩形 70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469468" y="3909695"/>
            <a:ext cx="10977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xmlns="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3722850" y="4152948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5" name="矩形 74">
            <a:extLst>
              <a:ext uri="{FF2B5EF4-FFF2-40B4-BE49-F238E27FC236}">
                <a16:creationId xmlns:a16="http://schemas.microsoft.com/office/drawing/2014/main" xmlns="" id="{E1DB421E-9ACF-464C-8ACB-D1AB43B55ABB}"/>
              </a:ext>
            </a:extLst>
          </p:cNvPr>
          <p:cNvSpPr/>
          <p:nvPr/>
        </p:nvSpPr>
        <p:spPr>
          <a:xfrm>
            <a:off x="3630021" y="3852212"/>
            <a:ext cx="15354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969236" y="4085386"/>
            <a:ext cx="7225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矩形 77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4342026" y="4024228"/>
            <a:ext cx="8531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矩形 78"/>
          <p:cNvSpPr/>
          <p:nvPr/>
        </p:nvSpPr>
        <p:spPr>
          <a:xfrm>
            <a:off x="3681848" y="3416962"/>
            <a:ext cx="1321921" cy="445628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0" name="组合 79"/>
          <p:cNvGrpSpPr/>
          <p:nvPr/>
        </p:nvGrpSpPr>
        <p:grpSpPr>
          <a:xfrm>
            <a:off x="2965516" y="3096480"/>
            <a:ext cx="585417" cy="276999"/>
            <a:chOff x="-4007534" y="10215563"/>
            <a:chExt cx="585417" cy="276999"/>
          </a:xfrm>
        </p:grpSpPr>
        <p:sp>
          <p:nvSpPr>
            <p:cNvPr id="81" name="矩形 80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直接连接符 81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3" name="组合 82"/>
          <p:cNvGrpSpPr/>
          <p:nvPr/>
        </p:nvGrpSpPr>
        <p:grpSpPr>
          <a:xfrm>
            <a:off x="2965502" y="3736885"/>
            <a:ext cx="585417" cy="276999"/>
            <a:chOff x="-4007534" y="10215563"/>
            <a:chExt cx="585417" cy="276999"/>
          </a:xfrm>
        </p:grpSpPr>
        <p:sp>
          <p:nvSpPr>
            <p:cNvPr id="84" name="矩形 83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5" name="直接连接符 84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6" name="矩形 85">
            <a:extLst>
              <a:ext uri="{FF2B5EF4-FFF2-40B4-BE49-F238E27FC236}">
                <a16:creationId xmlns:a16="http://schemas.microsoft.com/office/drawing/2014/main" xmlns="" id="{04F2603A-4C99-4014-9048-120CB6C8E32E}"/>
              </a:ext>
            </a:extLst>
          </p:cNvPr>
          <p:cNvSpPr/>
          <p:nvPr/>
        </p:nvSpPr>
        <p:spPr>
          <a:xfrm flipH="1">
            <a:off x="6181954" y="3798460"/>
            <a:ext cx="863268" cy="379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867" dirty="0" err="1">
                <a:latin typeface="Arial" panose="020B0604020202020204" pitchFamily="34" charset="0"/>
                <a:cs typeface="Arial" panose="020B0604020202020204" pitchFamily="34" charset="0"/>
              </a:rPr>
              <a:t>0.1s</a:t>
            </a:r>
            <a:endParaRPr lang="zh-CN" altLang="en-US" sz="186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51071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AC2502D-7B2E-4F08-B5EE-2805D9896CB1}"/>
              </a:ext>
            </a:extLst>
          </p:cNvPr>
          <p:cNvSpPr txBox="1">
            <a:spLocks/>
          </p:cNvSpPr>
          <p:nvPr/>
        </p:nvSpPr>
        <p:spPr>
          <a:xfrm>
            <a:off x="552450" y="319991"/>
            <a:ext cx="971550" cy="577970"/>
          </a:xfrm>
          <a:prstGeom prst="rect">
            <a:avLst/>
          </a:prstGeom>
        </p:spPr>
        <p:txBody>
          <a:bodyPr>
            <a:normAutofit lnSpcReduction="10000"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sz="3200" dirty="0" err="1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H3</a:t>
            </a:r>
            <a:endParaRPr lang="zh-CN" altLang="en-US" sz="32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9613" y="-1566641"/>
            <a:ext cx="5626473" cy="7736400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469468" y="3909695"/>
            <a:ext cx="10977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xmlns="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3722850" y="4152948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矩形 5">
            <a:extLst>
              <a:ext uri="{FF2B5EF4-FFF2-40B4-BE49-F238E27FC236}">
                <a16:creationId xmlns:a16="http://schemas.microsoft.com/office/drawing/2014/main" xmlns="" id="{E1DB421E-9ACF-464C-8ACB-D1AB43B55ABB}"/>
              </a:ext>
            </a:extLst>
          </p:cNvPr>
          <p:cNvSpPr/>
          <p:nvPr/>
        </p:nvSpPr>
        <p:spPr>
          <a:xfrm>
            <a:off x="3914501" y="3852212"/>
            <a:ext cx="7959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969236" y="4085386"/>
            <a:ext cx="7225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4342026" y="4024228"/>
            <a:ext cx="8531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3681848" y="3416962"/>
            <a:ext cx="1321921" cy="445628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2965516" y="3096480"/>
            <a:ext cx="585417" cy="276999"/>
            <a:chOff x="-4007534" y="10215563"/>
            <a:chExt cx="585417" cy="276999"/>
          </a:xfrm>
        </p:grpSpPr>
        <p:sp>
          <p:nvSpPr>
            <p:cNvPr id="11" name="矩形 10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11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" name="组合 12"/>
          <p:cNvGrpSpPr/>
          <p:nvPr/>
        </p:nvGrpSpPr>
        <p:grpSpPr>
          <a:xfrm>
            <a:off x="2965502" y="3736885"/>
            <a:ext cx="585417" cy="276999"/>
            <a:chOff x="-4007534" y="10215563"/>
            <a:chExt cx="585417" cy="276999"/>
          </a:xfrm>
        </p:grpSpPr>
        <p:sp>
          <p:nvSpPr>
            <p:cNvPr id="14" name="矩形 13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接连接符 14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6" name="矩形 15">
            <a:extLst>
              <a:ext uri="{FF2B5EF4-FFF2-40B4-BE49-F238E27FC236}">
                <a16:creationId xmlns:a16="http://schemas.microsoft.com/office/drawing/2014/main" xmlns="" id="{04F2603A-4C99-4014-9048-120CB6C8E32E}"/>
              </a:ext>
            </a:extLst>
          </p:cNvPr>
          <p:cNvSpPr/>
          <p:nvPr/>
        </p:nvSpPr>
        <p:spPr>
          <a:xfrm flipH="1">
            <a:off x="6181954" y="3798460"/>
            <a:ext cx="863268" cy="379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867" dirty="0" err="1">
                <a:latin typeface="Arial" panose="020B0604020202020204" pitchFamily="34" charset="0"/>
                <a:cs typeface="Arial" panose="020B0604020202020204" pitchFamily="34" charset="0"/>
              </a:rPr>
              <a:t>0.1s</a:t>
            </a:r>
            <a:endParaRPr lang="zh-CN" altLang="en-US" sz="186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14055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9184" y="-1386400"/>
            <a:ext cx="6134473" cy="8434900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726233" y="4364581"/>
            <a:ext cx="10977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xmlns="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3979615" y="4607834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矩形 5">
            <a:extLst>
              <a:ext uri="{FF2B5EF4-FFF2-40B4-BE49-F238E27FC236}">
                <a16:creationId xmlns:a16="http://schemas.microsoft.com/office/drawing/2014/main" xmlns="" id="{E1DB421E-9ACF-464C-8ACB-D1AB43B55ABB}"/>
              </a:ext>
            </a:extLst>
          </p:cNvPr>
          <p:cNvSpPr/>
          <p:nvPr/>
        </p:nvSpPr>
        <p:spPr>
          <a:xfrm>
            <a:off x="3886786" y="4307098"/>
            <a:ext cx="15354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4226001" y="4540272"/>
            <a:ext cx="7225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4598791" y="4479114"/>
            <a:ext cx="8531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3938613" y="3871848"/>
            <a:ext cx="1321921" cy="445628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3222281" y="3921753"/>
            <a:ext cx="585417" cy="276999"/>
            <a:chOff x="-4007534" y="10215563"/>
            <a:chExt cx="585417" cy="276999"/>
          </a:xfrm>
        </p:grpSpPr>
        <p:sp>
          <p:nvSpPr>
            <p:cNvPr id="11" name="矩形 10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11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" name="组合 12"/>
          <p:cNvGrpSpPr/>
          <p:nvPr/>
        </p:nvGrpSpPr>
        <p:grpSpPr>
          <a:xfrm>
            <a:off x="3222267" y="4469563"/>
            <a:ext cx="585417" cy="276999"/>
            <a:chOff x="-4007534" y="10215563"/>
            <a:chExt cx="585417" cy="276999"/>
          </a:xfrm>
        </p:grpSpPr>
        <p:sp>
          <p:nvSpPr>
            <p:cNvPr id="14" name="矩形 13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接连接符 14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6" name="矩形 15">
            <a:extLst>
              <a:ext uri="{FF2B5EF4-FFF2-40B4-BE49-F238E27FC236}">
                <a16:creationId xmlns:a16="http://schemas.microsoft.com/office/drawing/2014/main" xmlns="" id="{04F2603A-4C99-4014-9048-120CB6C8E32E}"/>
              </a:ext>
            </a:extLst>
          </p:cNvPr>
          <p:cNvSpPr/>
          <p:nvPr/>
        </p:nvSpPr>
        <p:spPr>
          <a:xfrm flipH="1">
            <a:off x="6438719" y="4253346"/>
            <a:ext cx="863268" cy="379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867" dirty="0" err="1" smtClean="0">
                <a:latin typeface="Arial" panose="020B0604020202020204" pitchFamily="34" charset="0"/>
                <a:cs typeface="Arial" panose="020B0604020202020204" pitchFamily="34" charset="0"/>
              </a:rPr>
              <a:t>0.1s</a:t>
            </a:r>
            <a:endParaRPr lang="zh-CN" altLang="en-US" sz="186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组合 16"/>
          <p:cNvGrpSpPr/>
          <p:nvPr/>
        </p:nvGrpSpPr>
        <p:grpSpPr>
          <a:xfrm>
            <a:off x="3212635" y="3622740"/>
            <a:ext cx="585417" cy="276999"/>
            <a:chOff x="-4007534" y="10215563"/>
            <a:chExt cx="585417" cy="276999"/>
          </a:xfrm>
        </p:grpSpPr>
        <p:sp>
          <p:nvSpPr>
            <p:cNvPr id="18" name="矩形 17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直接连接符 18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0" name="标题 1">
            <a:extLst>
              <a:ext uri="{FF2B5EF4-FFF2-40B4-BE49-F238E27FC236}">
                <a16:creationId xmlns:a16="http://schemas.microsoft.com/office/drawing/2014/main" xmlns="" id="{5EBBC431-FBC1-4527-BC36-D307E5F9B122}"/>
              </a:ext>
            </a:extLst>
          </p:cNvPr>
          <p:cNvSpPr txBox="1">
            <a:spLocks/>
          </p:cNvSpPr>
          <p:nvPr/>
        </p:nvSpPr>
        <p:spPr>
          <a:xfrm>
            <a:off x="533400" y="94704"/>
            <a:ext cx="1813560" cy="577970"/>
          </a:xfrm>
          <a:prstGeom prst="rect">
            <a:avLst/>
          </a:prstGeom>
        </p:spPr>
        <p:txBody>
          <a:bodyPr>
            <a:normAutofit lnSpcReduction="10000"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sz="32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GAPDH</a:t>
            </a:r>
            <a:r>
              <a:rPr lang="en-US" altLang="zh-CN" sz="32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</a:t>
            </a:r>
            <a:endParaRPr lang="zh-CN" altLang="en-US" sz="32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49645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标题 1">
            <a:extLst>
              <a:ext uri="{FF2B5EF4-FFF2-40B4-BE49-F238E27FC236}">
                <a16:creationId xmlns:a16="http://schemas.microsoft.com/office/drawing/2014/main" xmlns="" id="{5EBBC431-FBC1-4527-BC36-D307E5F9B122}"/>
              </a:ext>
            </a:extLst>
          </p:cNvPr>
          <p:cNvSpPr txBox="1">
            <a:spLocks/>
          </p:cNvSpPr>
          <p:nvPr/>
        </p:nvSpPr>
        <p:spPr>
          <a:xfrm>
            <a:off x="533400" y="94704"/>
            <a:ext cx="1813560" cy="577970"/>
          </a:xfrm>
          <a:prstGeom prst="rect">
            <a:avLst/>
          </a:prstGeom>
        </p:spPr>
        <p:txBody>
          <a:bodyPr>
            <a:normAutofit lnSpcReduction="10000"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sz="32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GAPDH</a:t>
            </a:r>
            <a:r>
              <a:rPr lang="en-US" altLang="zh-CN" sz="32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</a:t>
            </a:r>
            <a:endParaRPr lang="zh-CN" altLang="en-US" sz="32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2415" y="-2052661"/>
            <a:ext cx="6134400" cy="8434800"/>
          </a:xfrm>
          <a:prstGeom prst="rect">
            <a:avLst/>
          </a:prstGeom>
        </p:spPr>
      </p:pic>
      <p:sp>
        <p:nvSpPr>
          <p:cNvPr id="71" name="矩形 70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726233" y="4364581"/>
            <a:ext cx="10977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xmlns="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3979615" y="4607834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5" name="矩形 74">
            <a:extLst>
              <a:ext uri="{FF2B5EF4-FFF2-40B4-BE49-F238E27FC236}">
                <a16:creationId xmlns:a16="http://schemas.microsoft.com/office/drawing/2014/main" xmlns="" id="{E1DB421E-9ACF-464C-8ACB-D1AB43B55ABB}"/>
              </a:ext>
            </a:extLst>
          </p:cNvPr>
          <p:cNvSpPr/>
          <p:nvPr/>
        </p:nvSpPr>
        <p:spPr>
          <a:xfrm>
            <a:off x="4130626" y="4307098"/>
            <a:ext cx="7959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矩形 75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4226001" y="4540272"/>
            <a:ext cx="7225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4598791" y="4479114"/>
            <a:ext cx="8531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矩形 77"/>
          <p:cNvSpPr/>
          <p:nvPr/>
        </p:nvSpPr>
        <p:spPr>
          <a:xfrm>
            <a:off x="3938613" y="3871848"/>
            <a:ext cx="1321921" cy="445628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9" name="组合 78"/>
          <p:cNvGrpSpPr/>
          <p:nvPr/>
        </p:nvGrpSpPr>
        <p:grpSpPr>
          <a:xfrm>
            <a:off x="3222281" y="3921753"/>
            <a:ext cx="585417" cy="276999"/>
            <a:chOff x="-4007534" y="10215563"/>
            <a:chExt cx="585417" cy="276999"/>
          </a:xfrm>
        </p:grpSpPr>
        <p:sp>
          <p:nvSpPr>
            <p:cNvPr id="80" name="矩形 79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1" name="直接连接符 80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2" name="组合 81"/>
          <p:cNvGrpSpPr/>
          <p:nvPr/>
        </p:nvGrpSpPr>
        <p:grpSpPr>
          <a:xfrm>
            <a:off x="3222267" y="4469563"/>
            <a:ext cx="585417" cy="276999"/>
            <a:chOff x="-4007534" y="10215563"/>
            <a:chExt cx="585417" cy="276999"/>
          </a:xfrm>
        </p:grpSpPr>
        <p:sp>
          <p:nvSpPr>
            <p:cNvPr id="83" name="矩形 82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4" name="直接连接符 8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5" name="矩形 84">
            <a:extLst>
              <a:ext uri="{FF2B5EF4-FFF2-40B4-BE49-F238E27FC236}">
                <a16:creationId xmlns:a16="http://schemas.microsoft.com/office/drawing/2014/main" xmlns="" id="{04F2603A-4C99-4014-9048-120CB6C8E32E}"/>
              </a:ext>
            </a:extLst>
          </p:cNvPr>
          <p:cNvSpPr/>
          <p:nvPr/>
        </p:nvSpPr>
        <p:spPr>
          <a:xfrm flipH="1">
            <a:off x="6438719" y="4253346"/>
            <a:ext cx="863268" cy="379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867" dirty="0" err="1" smtClean="0">
                <a:latin typeface="Arial" panose="020B0604020202020204" pitchFamily="34" charset="0"/>
                <a:cs typeface="Arial" panose="020B0604020202020204" pitchFamily="34" charset="0"/>
              </a:rPr>
              <a:t>0.1s</a:t>
            </a:r>
            <a:endParaRPr lang="zh-CN" altLang="en-US" sz="186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6" name="组合 85"/>
          <p:cNvGrpSpPr/>
          <p:nvPr/>
        </p:nvGrpSpPr>
        <p:grpSpPr>
          <a:xfrm>
            <a:off x="3212635" y="3622740"/>
            <a:ext cx="585417" cy="276999"/>
            <a:chOff x="-4007534" y="10215563"/>
            <a:chExt cx="585417" cy="276999"/>
          </a:xfrm>
        </p:grpSpPr>
        <p:sp>
          <p:nvSpPr>
            <p:cNvPr id="87" name="矩形 86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8" name="直接连接符 87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308677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92</Words>
  <Application>Microsoft Office PowerPoint</Application>
  <PresentationFormat>宽屏</PresentationFormat>
  <Paragraphs>74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3" baseType="lpstr">
      <vt:lpstr>Arial Unicode MS</vt:lpstr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敏</dc:creator>
  <cp:lastModifiedBy>Yuexiang Wang</cp:lastModifiedBy>
  <cp:revision>13</cp:revision>
  <dcterms:created xsi:type="dcterms:W3CDTF">2024-03-14T02:33:39Z</dcterms:created>
  <dcterms:modified xsi:type="dcterms:W3CDTF">2024-03-14T05:01:17Z</dcterms:modified>
</cp:coreProperties>
</file>